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0AA53-C66B-4FB0-930B-E5639973F8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E6185-ABB0-4DA4-ACFB-797257EF26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5C04D-6439-4728-ABD7-2F3FB5863B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7044B-A47D-44AC-A99B-74E50D299B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3661A-2301-4337-8B5F-AEBD786EAA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5184E-C021-4C21-A1ED-2D55A6A02B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71BE3-E876-470C-B90A-BDDC52DFE8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A6673-F4A0-45B4-ACED-5547DA8D2E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50E5B-8763-48CB-A3AB-A04F90FF23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D8898-ED35-4349-9E89-D515AC280C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2F480-9241-4D47-A1AB-1609845FA1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4031A-ACA9-4DE3-AF9E-3CA3033F5C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F3AD27-EEB6-405B-81A7-9FA0C0E407F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240" y="0"/>
            <a:ext cx="1282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assandr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I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6320" y="836640"/>
            <a:ext cx="6746760" cy="679284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 rot="1059000">
            <a:off x="281160" y="3033360"/>
            <a:ext cx="342720" cy="333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37040" y="3102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65480" y="3044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25880" y="3152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452760" y="1042920"/>
            <a:ext cx="219240" cy="219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43000" y="4114800"/>
            <a:ext cx="195120" cy="181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81160" y="4075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48440" y="10843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383280" y="10810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168880" y="8118360"/>
            <a:ext cx="274680" cy="250920"/>
          </a:xfrm>
          <a:prstGeom prst="ellipse">
            <a:avLst/>
          </a:prstGeom>
          <a:solidFill>
            <a:srgbClr val="33cc33"/>
          </a:solidFill>
          <a:ln w="93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402160" y="810576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167440" y="8445600"/>
            <a:ext cx="274680" cy="25056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400360" y="843264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ixed tissu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2880" y="0"/>
            <a:ext cx="1194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lonist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636480" y="976320"/>
            <a:ext cx="5450040" cy="565956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2933640" y="876240"/>
            <a:ext cx="881280" cy="619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399120" y="13273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438720" y="1328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526200" y="13399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484800" y="1332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561120" y="1346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102120" y="13208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20632200">
            <a:off x="5605560" y="2943000"/>
            <a:ext cx="609480" cy="271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513760" y="30034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cc0066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338720" y="6010200"/>
            <a:ext cx="199800" cy="190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239000" y="5900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505320" y="6238800"/>
            <a:ext cx="118800" cy="419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430800" y="61214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305000">
            <a:off x="2415960" y="6097320"/>
            <a:ext cx="118800" cy="419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408400" y="5975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877400">
            <a:off x="2069640" y="5942160"/>
            <a:ext cx="119160" cy="419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086200" y="58435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cc0066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2663400">
            <a:off x="1314360" y="5402160"/>
            <a:ext cx="236520" cy="419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473480" y="53784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403640" y="5303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433880" y="5338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19921200">
            <a:off x="755640" y="4782960"/>
            <a:ext cx="530280" cy="64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184760" y="5003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162440" y="4976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144800" y="4944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127520" y="49086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00520" y="48578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116360" y="48880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065600" y="48038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000440" y="46386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0808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216440" y="5045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52520" y="3489480"/>
            <a:ext cx="530280" cy="649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821160" y="3726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367240" y="6594480"/>
            <a:ext cx="274680" cy="250920"/>
          </a:xfrm>
          <a:prstGeom prst="ellipse">
            <a:avLst/>
          </a:prstGeom>
          <a:solidFill>
            <a:srgbClr val="33cc33"/>
          </a:solidFill>
          <a:ln w="93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600520" y="658188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365800" y="6921360"/>
            <a:ext cx="274680" cy="25092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598720" y="690876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ixed tissu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365800" y="7248600"/>
            <a:ext cx="274680" cy="250920"/>
          </a:xfrm>
          <a:prstGeom prst="ellipse">
            <a:avLst/>
          </a:prstGeom>
          <a:solidFill>
            <a:srgbClr val="ffff00"/>
          </a:solidFill>
          <a:ln w="1908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599800" y="7236000"/>
            <a:ext cx="102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dosper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367240" y="7574040"/>
            <a:ext cx="274680" cy="25092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599800" y="756144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mbry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373720" y="7902720"/>
            <a:ext cx="274680" cy="250560"/>
          </a:xfrm>
          <a:prstGeom prst="ellipse">
            <a:avLst/>
          </a:prstGeom>
          <a:solidFill>
            <a:srgbClr val="33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606280" y="788976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le flow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370480" y="8232840"/>
            <a:ext cx="274680" cy="250920"/>
          </a:xfrm>
          <a:prstGeom prst="ellipse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604840" y="8220240"/>
            <a:ext cx="52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o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"/>
          <p:cNvSpPr/>
          <p:nvPr/>
        </p:nvSpPr>
        <p:spPr>
          <a:xfrm>
            <a:off x="3600" y="0"/>
            <a:ext cx="2285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iep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TR-retro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270000" y="946080"/>
            <a:ext cx="6159240" cy="6201000"/>
          </a:xfrm>
          <a:prstGeom prst="rect">
            <a:avLst/>
          </a:prstGeom>
          <a:ln w="0">
            <a:noFill/>
          </a:ln>
        </p:spPr>
      </p:pic>
      <p:sp>
        <p:nvSpPr>
          <p:cNvPr id="105" name=""/>
          <p:cNvSpPr/>
          <p:nvPr/>
        </p:nvSpPr>
        <p:spPr>
          <a:xfrm>
            <a:off x="5197320" y="6805440"/>
            <a:ext cx="274680" cy="250920"/>
          </a:xfrm>
          <a:prstGeom prst="ellipse">
            <a:avLst/>
          </a:prstGeom>
          <a:solidFill>
            <a:srgbClr val="33cc33"/>
          </a:solidFill>
          <a:ln w="93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430600" y="679284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203800" y="7142040"/>
            <a:ext cx="274680" cy="250920"/>
          </a:xfrm>
          <a:prstGeom prst="ellipse">
            <a:avLst/>
          </a:prstGeom>
          <a:solidFill>
            <a:srgbClr val="33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5436360" y="712944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le flow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"/>
          <p:cNvGrpSpPr/>
          <p:nvPr/>
        </p:nvGrpSpPr>
        <p:grpSpPr>
          <a:xfrm>
            <a:off x="5199120" y="7413480"/>
            <a:ext cx="1423080" cy="276480"/>
            <a:chOff x="5199120" y="7413480"/>
            <a:chExt cx="1423080" cy="276480"/>
          </a:xfrm>
        </p:grpSpPr>
        <p:sp>
          <p:nvSpPr>
            <p:cNvPr id="110" name=""/>
            <p:cNvSpPr/>
            <p:nvPr/>
          </p:nvSpPr>
          <p:spPr>
            <a:xfrm>
              <a:off x="5199120" y="7426080"/>
              <a:ext cx="274320" cy="250920"/>
            </a:xfrm>
            <a:prstGeom prst="ellipse">
              <a:avLst/>
            </a:prstGeom>
            <a:solidFill>
              <a:srgbClr val="00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430960" y="7413480"/>
              <a:ext cx="1191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ultured cel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2" name=""/>
          <p:cNvSpPr/>
          <p:nvPr/>
        </p:nvSpPr>
        <p:spPr>
          <a:xfrm>
            <a:off x="223920" y="3971880"/>
            <a:ext cx="612720" cy="2113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"/>
          <p:cNvGrpSpPr/>
          <p:nvPr/>
        </p:nvGrpSpPr>
        <p:grpSpPr>
          <a:xfrm>
            <a:off x="687600" y="3906720"/>
            <a:ext cx="275400" cy="336960"/>
            <a:chOff x="687600" y="3906720"/>
            <a:chExt cx="275400" cy="336960"/>
          </a:xfrm>
        </p:grpSpPr>
        <p:sp>
          <p:nvSpPr>
            <p:cNvPr id="114" name=""/>
            <p:cNvSpPr/>
            <p:nvPr/>
          </p:nvSpPr>
          <p:spPr>
            <a:xfrm>
              <a:off x="690840" y="396720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ffff"/>
                  </a:solidFill>
                  <a:latin typeface="Times New Roman"/>
                  <a:ea typeface="Times New Roman"/>
                </a:rPr>
                <a:t>●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687600" y="390672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ffff"/>
                  </a:solidFill>
                  <a:latin typeface="Times New Roman"/>
                  <a:ea typeface="Times New Roman"/>
                </a:rPr>
                <a:t>●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6" name=""/>
          <p:cNvSpPr/>
          <p:nvPr/>
        </p:nvSpPr>
        <p:spPr>
          <a:xfrm rot="1411200">
            <a:off x="323640" y="2513160"/>
            <a:ext cx="680760" cy="12571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999000" y="2735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987840" y="2762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862200" y="30304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954360" y="2824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939960" y="2855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922680" y="2886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912960" y="2913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900360" y="2944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883080" y="2978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849600" y="3063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873360" y="3002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837000" y="31035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ffff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972000" y="2793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022760" y="2701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384120" y="909720"/>
            <a:ext cx="5788080" cy="5727600"/>
          </a:xfrm>
          <a:prstGeom prst="rect">
            <a:avLst/>
          </a:prstGeom>
          <a:ln w="0">
            <a:noFill/>
          </a:ln>
        </p:spPr>
      </p:pic>
      <p:sp>
        <p:nvSpPr>
          <p:cNvPr id="132" name=""/>
          <p:cNvSpPr/>
          <p:nvPr/>
        </p:nvSpPr>
        <p:spPr>
          <a:xfrm>
            <a:off x="155520" y="3575160"/>
            <a:ext cx="649440" cy="258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rot="19000800">
            <a:off x="880560" y="1466640"/>
            <a:ext cx="1094040" cy="5601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600" y="0"/>
            <a:ext cx="2285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ran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TR-retro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451160" y="1800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632240" y="16477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5122800" y="6361200"/>
            <a:ext cx="274680" cy="250560"/>
          </a:xfrm>
          <a:prstGeom prst="ellipse">
            <a:avLst/>
          </a:prstGeom>
          <a:solidFill>
            <a:srgbClr val="33cc33"/>
          </a:solidFill>
          <a:ln w="93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5356080" y="634824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119560" y="6703920"/>
            <a:ext cx="274680" cy="250920"/>
          </a:xfrm>
          <a:prstGeom prst="ellipse">
            <a:avLst/>
          </a:prstGeom>
          <a:solidFill>
            <a:srgbClr val="33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5352120" y="669132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le flow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590840" y="1681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256040" y="19969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659160" y="35434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662400" y="3591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391040" y="18604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408320" y="1828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292400" y="1959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1357560" y="1886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330560" y="1919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555920" y="1708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526040" y="1736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494000" y="1766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" descr=""/>
          <p:cNvPicPr/>
          <p:nvPr/>
        </p:nvPicPr>
        <p:blipFill>
          <a:blip r:embed="rId1"/>
          <a:srcRect l="2155" t="6438" r="6464" b="2146"/>
          <a:stretch/>
        </p:blipFill>
        <p:spPr>
          <a:xfrm>
            <a:off x="0" y="538200"/>
            <a:ext cx="6724800" cy="6750000"/>
          </a:xfrm>
          <a:prstGeom prst="rect">
            <a:avLst/>
          </a:prstGeom>
          <a:ln w="0">
            <a:noFill/>
          </a:ln>
        </p:spPr>
      </p:pic>
      <p:sp>
        <p:nvSpPr>
          <p:cNvPr id="154" name=""/>
          <p:cNvSpPr/>
          <p:nvPr/>
        </p:nvSpPr>
        <p:spPr>
          <a:xfrm>
            <a:off x="0" y="3355920"/>
            <a:ext cx="358920" cy="549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rot="19836600">
            <a:off x="614520" y="5295960"/>
            <a:ext cx="231480" cy="3697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rot="19307400">
            <a:off x="965160" y="5768640"/>
            <a:ext cx="231840" cy="3697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rot="18778200">
            <a:off x="1189800" y="5996520"/>
            <a:ext cx="231480" cy="370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rot="18426000">
            <a:off x="1485000" y="6230160"/>
            <a:ext cx="231840" cy="370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rot="17868000">
            <a:off x="1861200" y="6374520"/>
            <a:ext cx="231840" cy="566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rot="17407200">
            <a:off x="2165400" y="6719400"/>
            <a:ext cx="525240" cy="566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rot="16784400">
            <a:off x="2682720" y="6849720"/>
            <a:ext cx="525600" cy="566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029400" y="6800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202120" y="6599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743480" y="6373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454480" y="6689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1627560" y="6296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113200" y="6561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806920" y="67644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540160" y="6707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289600" y="66247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87560" y="35575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723040" y="6750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895840" y="6781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829160" y="6419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584800" y="67215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○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332440" y="6642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5272200" y="6531120"/>
            <a:ext cx="274680" cy="250560"/>
          </a:xfrm>
          <a:prstGeom prst="ellipse">
            <a:avLst/>
          </a:prstGeom>
          <a:solidFill>
            <a:srgbClr val="33cc33"/>
          </a:solidFill>
          <a:ln w="93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5505480" y="651816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270400" y="6858000"/>
            <a:ext cx="274680" cy="25092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5503680" y="684540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ixed tissu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5270400" y="7184880"/>
            <a:ext cx="274680" cy="250920"/>
          </a:xfrm>
          <a:prstGeom prst="ellipse">
            <a:avLst/>
          </a:prstGeom>
          <a:solidFill>
            <a:srgbClr val="ffff00"/>
          </a:solidFill>
          <a:ln w="1908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5504760" y="7172280"/>
            <a:ext cx="102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dosper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5272200" y="7488360"/>
            <a:ext cx="274680" cy="250560"/>
          </a:xfrm>
          <a:prstGeom prst="ellipse">
            <a:avLst/>
          </a:prstGeom>
          <a:solidFill>
            <a:srgbClr val="ccff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5505120" y="747540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ea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5272200" y="7815240"/>
            <a:ext cx="274680" cy="25092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5504760" y="780264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mbry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278320" y="8143920"/>
            <a:ext cx="274680" cy="250920"/>
          </a:xfrm>
          <a:prstGeom prst="ellipse">
            <a:avLst/>
          </a:prstGeom>
          <a:solidFill>
            <a:srgbClr val="33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5510880" y="813132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le flow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275440" y="8474040"/>
            <a:ext cx="274320" cy="250920"/>
          </a:xfrm>
          <a:prstGeom prst="ellipse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5509440" y="8461440"/>
            <a:ext cx="52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o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1665720" y="63216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0808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87560" y="3506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0808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789560" y="6396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0808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1697400" y="6345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0808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986560" y="67928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0808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673720" y="67327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ccff66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941920" y="67896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0808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5276880" y="8785080"/>
            <a:ext cx="274680" cy="2509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508720" y="8772480"/>
            <a:ext cx="12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emale flow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162520" y="6578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768760" y="6751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600" y="0"/>
            <a:ext cx="2285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TR-retro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632320" y="6727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ccff66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856240" y="67802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3073680" y="6804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410200" y="66754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ccff66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2367360" y="66564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238840" y="6611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499120" y="6700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1862280" y="64404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2072160" y="6539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2030760" y="6523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900440" y="64627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932480" y="64785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1997280" y="6507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1960920" y="6491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1519560" y="6203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1590840" y="6264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1492560" y="6180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1448280" y="6151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1410120" y="6126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1233720" y="5981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011600" y="57546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598680" y="5160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" name="" descr=""/>
          <p:cNvPicPr/>
          <p:nvPr/>
        </p:nvPicPr>
        <p:blipFill>
          <a:blip r:embed="rId1"/>
          <a:srcRect l="0" t="4326" r="8409" b="0"/>
          <a:stretch/>
        </p:blipFill>
        <p:spPr>
          <a:xfrm>
            <a:off x="0" y="900000"/>
            <a:ext cx="6281640" cy="6372360"/>
          </a:xfrm>
          <a:prstGeom prst="rect">
            <a:avLst/>
          </a:prstGeom>
          <a:ln w="0">
            <a:noFill/>
          </a:ln>
        </p:spPr>
      </p:pic>
      <p:sp>
        <p:nvSpPr>
          <p:cNvPr id="226" name=""/>
          <p:cNvSpPr/>
          <p:nvPr/>
        </p:nvSpPr>
        <p:spPr>
          <a:xfrm rot="18085200">
            <a:off x="83160" y="2104200"/>
            <a:ext cx="917640" cy="528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 rot="19954200">
            <a:off x="1387080" y="1123560"/>
            <a:ext cx="917640" cy="297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 rot="19048800">
            <a:off x="522360" y="1358640"/>
            <a:ext cx="917640" cy="649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rot="17546400">
            <a:off x="-33840" y="2511360"/>
            <a:ext cx="917640" cy="4366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114480" y="3733920"/>
            <a:ext cx="280800" cy="290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rot="19281600">
            <a:off x="5105160" y="6148080"/>
            <a:ext cx="204840" cy="4903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rot="20741400">
            <a:off x="6026040" y="2854440"/>
            <a:ext cx="757440" cy="290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 rot="20332200">
            <a:off x="5932440" y="2583000"/>
            <a:ext cx="822240" cy="290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 rot="19923000">
            <a:off x="5800320" y="2265120"/>
            <a:ext cx="822240" cy="290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174960" y="0"/>
            <a:ext cx="2285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Ze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TR-retro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203800" y="6929280"/>
            <a:ext cx="274680" cy="250920"/>
          </a:xfrm>
          <a:prstGeom prst="ellipse">
            <a:avLst/>
          </a:prstGeom>
          <a:solidFill>
            <a:srgbClr val="33cc33"/>
          </a:solidFill>
          <a:ln w="93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5437080" y="691668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5202360" y="7256520"/>
            <a:ext cx="274680" cy="25092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5435280" y="724392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ixed tissu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5202360" y="7564320"/>
            <a:ext cx="274680" cy="250920"/>
          </a:xfrm>
          <a:prstGeom prst="ellipse">
            <a:avLst/>
          </a:prstGeom>
          <a:solidFill>
            <a:srgbClr val="ffff00"/>
          </a:solidFill>
          <a:ln w="1908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5436360" y="7551720"/>
            <a:ext cx="102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dosper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5203800" y="7877160"/>
            <a:ext cx="274680" cy="250920"/>
          </a:xfrm>
          <a:prstGeom prst="ellipse">
            <a:avLst/>
          </a:prstGeom>
          <a:solidFill>
            <a:srgbClr val="ccff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5436720" y="786456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ea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5200560" y="8180280"/>
            <a:ext cx="274680" cy="250920"/>
          </a:xfrm>
          <a:prstGeom prst="ellipse">
            <a:avLst/>
          </a:prstGeom>
          <a:solidFill>
            <a:srgbClr val="33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5433120" y="816768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le flow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5712120" y="2394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5808960" y="2610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5867640" y="2782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5888520" y="2808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5947200" y="2986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4982040" y="6064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5831280" y="2670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850360" y="2712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866200" y="2762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4950000" y="6099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5723280" y="24145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5905800" y="28544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5821560" y="2631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32200" y="3743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5753520" y="2459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5772600" y="2492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5926320" y="2894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cc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5963040" y="3035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ccff66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5937480" y="29383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○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5214960" y="8456760"/>
            <a:ext cx="274680" cy="2505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5446800" y="8443800"/>
            <a:ext cx="120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emale flow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 rot="19954200">
            <a:off x="928800" y="1050480"/>
            <a:ext cx="917640" cy="290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781200" y="20494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671760" y="21970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721080" y="21272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659160" y="22399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754560" y="20844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694080" y="2162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708480" y="2141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○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643320" y="22716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486000" y="25495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439920" y="26496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470160" y="25765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430560" y="2690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528840" y="24782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73320" y="2836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624240" y="2303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417960" y="2728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516240" y="25034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455760" y="26100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85920" y="2797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02120" y="27558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cc33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551160" y="24400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567000" y="24084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586080" y="2376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605160" y="2344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1144800" y="16351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1113120" y="1670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943200" y="18446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1527480" y="13431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2021040" y="10987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ccff66"/>
                </a:solidFill>
                <a:latin typeface="Times New Roman"/>
                <a:ea typeface="Times New Roman"/>
              </a:rPr>
              <a:t>●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8T09:34:47Z</dcterms:created>
  <dc:creator>Carlos Vicient</dc:creator>
  <dc:description/>
  <dc:language>en-US</dc:language>
  <cp:lastModifiedBy>Carlos Vicient</cp:lastModifiedBy>
  <dcterms:modified xsi:type="dcterms:W3CDTF">2010-10-22T08:58:20Z</dcterms:modified>
  <cp:revision>13</cp:revision>
  <dc:subject/>
  <dc:title>Diapositiva 1</dc:title>
</cp:coreProperties>
</file>